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B9449-7925-4220-9B4A-A8D11C84EB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F386A-2E2B-4CA7-BE65-87BC9EBF4A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CDEF0-1E78-4BA3-AD16-3F183F5C3E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AD877-2D30-48EB-8CF6-21BCD9E123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D1EA7-C0EB-4D9D-B352-3498543CB8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93F97-F981-4D79-BBF8-9D83420C33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1C8C4-B5F6-43CB-B877-372936EEA1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78918-D123-4853-8FA5-97B7DFEA44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C497D-89AD-41EA-8445-6E662E504A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E1A80-1ED9-4CD1-9471-F2E060A806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34D85-9278-4D25-B0CA-7E9501E632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A4264-A4B8-4224-9755-7D1D168092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E88681-DCAF-4B98-9B13-5198BACFCA7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116000" y="260280"/>
            <a:ext cx="6769080" cy="52149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55640" y="5661000"/>
            <a:ext cx="7942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4. Comparison of nucleotide sequence of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ap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of pCPPB-1 against the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ap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of type E isolat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(JGS1987)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Blue bar indicates primer sites using multiplex PCR toxin genotyping assay [8]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3:40Z</dcterms:modified>
  <cp:revision>4</cp:revision>
  <dc:subject/>
  <dc:title>スライド 1</dc:title>
</cp:coreProperties>
</file>